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38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FBB7-CC59-4645-B28C-A4B1CA1B0640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C994B-3F0F-4427-9BFC-6D9FD57C89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72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FBB7-CC59-4645-B28C-A4B1CA1B0640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C994B-3F0F-4427-9BFC-6D9FD57C89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208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FBB7-CC59-4645-B28C-A4B1CA1B0640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C994B-3F0F-4427-9BFC-6D9FD57C89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640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FBB7-CC59-4645-B28C-A4B1CA1B0640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C994B-3F0F-4427-9BFC-6D9FD57C89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067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FBB7-CC59-4645-B28C-A4B1CA1B0640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C994B-3F0F-4427-9BFC-6D9FD57C89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332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FBB7-CC59-4645-B28C-A4B1CA1B0640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C994B-3F0F-4427-9BFC-6D9FD57C89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467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FBB7-CC59-4645-B28C-A4B1CA1B0640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C994B-3F0F-4427-9BFC-6D9FD57C89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6034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FBB7-CC59-4645-B28C-A4B1CA1B0640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C994B-3F0F-4427-9BFC-6D9FD57C89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650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FBB7-CC59-4645-B28C-A4B1CA1B0640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C994B-3F0F-4427-9BFC-6D9FD57C89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01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FBB7-CC59-4645-B28C-A4B1CA1B0640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C994B-3F0F-4427-9BFC-6D9FD57C89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833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FBB7-CC59-4645-B28C-A4B1CA1B0640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C994B-3F0F-4427-9BFC-6D9FD57C89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123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BCFBB7-CC59-4645-B28C-A4B1CA1B0640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0C994B-3F0F-4427-9BFC-6D9FD57C89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316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184639" y="376"/>
            <a:ext cx="968033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. The morphology on PDA of four transformants of </a:t>
            </a:r>
            <a:r>
              <a:rPr lang="en-US" b="1" i="1" dirty="0"/>
              <a:t>agl</a:t>
            </a:r>
            <a:r>
              <a:rPr lang="en-US" b="1" dirty="0"/>
              <a:t>-2 complementation infected by a mycovirus, SsHV2-L at four days old, showing no significant difference compared to the transformants without virus infection (statistical comparison shown in Fig 3B)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82" t="3679" r="13994" b="689"/>
          <a:stretch/>
        </p:blipFill>
        <p:spPr>
          <a:xfrm>
            <a:off x="64915" y="923714"/>
            <a:ext cx="2359786" cy="235978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83603" y="3389835"/>
            <a:ext cx="1738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 transformant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96" t="1494" r="16494"/>
          <a:stretch/>
        </p:blipFill>
        <p:spPr>
          <a:xfrm>
            <a:off x="2500011" y="923714"/>
            <a:ext cx="2373553" cy="235978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33" t="3908" r="12614" b="3677"/>
          <a:stretch/>
        </p:blipFill>
        <p:spPr>
          <a:xfrm>
            <a:off x="4938764" y="923706"/>
            <a:ext cx="2350989" cy="2359794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78" t="8161" r="15459" b="4023"/>
          <a:stretch/>
        </p:blipFill>
        <p:spPr>
          <a:xfrm>
            <a:off x="7419561" y="927335"/>
            <a:ext cx="2356166" cy="2356166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DE82FEDD-4C0E-4966-91D3-8F70F0984298}"/>
              </a:ext>
            </a:extLst>
          </p:cNvPr>
          <p:cNvSpPr txBox="1"/>
          <p:nvPr/>
        </p:nvSpPr>
        <p:spPr>
          <a:xfrm>
            <a:off x="2824987" y="3380877"/>
            <a:ext cx="1738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 transforman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6B464F2-ED85-4A68-A72F-1BD9E0E35E52}"/>
              </a:ext>
            </a:extLst>
          </p:cNvPr>
          <p:cNvSpPr txBox="1"/>
          <p:nvPr/>
        </p:nvSpPr>
        <p:spPr>
          <a:xfrm>
            <a:off x="5323166" y="3392829"/>
            <a:ext cx="1738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 transforman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C4215B6-10E6-48F3-9823-D69CE081F529}"/>
              </a:ext>
            </a:extLst>
          </p:cNvPr>
          <p:cNvSpPr txBox="1"/>
          <p:nvPr/>
        </p:nvSpPr>
        <p:spPr>
          <a:xfrm>
            <a:off x="7648025" y="3410760"/>
            <a:ext cx="1738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 transformant</a:t>
            </a:r>
          </a:p>
        </p:txBody>
      </p:sp>
    </p:spTree>
    <p:extLst>
      <p:ext uri="{BB962C8B-B14F-4D97-AF65-F5344CB8AC3E}">
        <p14:creationId xmlns:p14="http://schemas.microsoft.com/office/powerpoint/2010/main" val="1629015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5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wner</dc:creator>
  <cp:lastModifiedBy>Shinyi Marzano</cp:lastModifiedBy>
  <cp:revision>3</cp:revision>
  <dcterms:created xsi:type="dcterms:W3CDTF">2019-04-15T22:04:44Z</dcterms:created>
  <dcterms:modified xsi:type="dcterms:W3CDTF">2019-07-18T18:39:54Z</dcterms:modified>
</cp:coreProperties>
</file>